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721850" cy="12601575"/>
  <p:notesSz cx="6858000" cy="9144000"/>
  <p:defaultTextStyle>
    <a:defPPr>
      <a:defRPr lang="de-DE"/>
    </a:defPPr>
    <a:lvl1pPr marL="0" algn="l" defTabSz="1275588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37794" algn="l" defTabSz="1275588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75588" algn="l" defTabSz="1275588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913382" algn="l" defTabSz="1275588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51176" algn="l" defTabSz="1275588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188970" algn="l" defTabSz="1275588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826764" algn="l" defTabSz="1275588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64558" algn="l" defTabSz="1275588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102352" algn="l" defTabSz="1275588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969">
          <p15:clr>
            <a:srgbClr val="A4A3A4"/>
          </p15:clr>
        </p15:guide>
        <p15:guide id="2" pos="306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8BF52E9-F0B9-4DC1-B20F-B1AA370E85CC}" v="2" dt="2024-02-26T00:52:36.55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64" d="100"/>
          <a:sy n="64" d="100"/>
        </p:scale>
        <p:origin x="-2880" y="-42"/>
      </p:cViewPr>
      <p:guideLst>
        <p:guide orient="horz" pos="3969"/>
        <p:guide pos="306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ominik Aumann" userId="013c187a20e8f01a" providerId="LiveId" clId="{88BF52E9-F0B9-4DC1-B20F-B1AA370E85CC}"/>
    <pc:docChg chg="modSld sldOrd">
      <pc:chgData name="Dominik Aumann" userId="013c187a20e8f01a" providerId="LiveId" clId="{88BF52E9-F0B9-4DC1-B20F-B1AA370E85CC}" dt="2024-02-26T00:52:45.042" v="13" actId="1076"/>
      <pc:docMkLst>
        <pc:docMk/>
      </pc:docMkLst>
      <pc:sldChg chg="addSp modSp mod">
        <pc:chgData name="Dominik Aumann" userId="013c187a20e8f01a" providerId="LiveId" clId="{88BF52E9-F0B9-4DC1-B20F-B1AA370E85CC}" dt="2024-02-26T00:52:45.042" v="13" actId="1076"/>
        <pc:sldMkLst>
          <pc:docMk/>
          <pc:sldMk cId="791795413" sldId="256"/>
        </pc:sldMkLst>
        <pc:spChg chg="add mod">
          <ac:chgData name="Dominik Aumann" userId="013c187a20e8f01a" providerId="LiveId" clId="{88BF52E9-F0B9-4DC1-B20F-B1AA370E85CC}" dt="2024-02-26T00:52:45.042" v="13" actId="1076"/>
          <ac:spMkLst>
            <pc:docMk/>
            <pc:sldMk cId="791795413" sldId="256"/>
            <ac:spMk id="2" creationId="{F4910726-D9AF-55DE-25CD-BD16BD52F168}"/>
          </ac:spMkLst>
        </pc:spChg>
      </pc:sldChg>
      <pc:sldChg chg="modSp ord">
        <pc:chgData name="Dominik Aumann" userId="013c187a20e8f01a" providerId="LiveId" clId="{88BF52E9-F0B9-4DC1-B20F-B1AA370E85CC}" dt="2024-02-26T00:52:19.079" v="2"/>
        <pc:sldMkLst>
          <pc:docMk/>
          <pc:sldMk cId="772863212" sldId="257"/>
        </pc:sldMkLst>
        <pc:picChg chg="mod">
          <ac:chgData name="Dominik Aumann" userId="013c187a20e8f01a" providerId="LiveId" clId="{88BF52E9-F0B9-4DC1-B20F-B1AA370E85CC}" dt="2024-02-26T00:52:16.142" v="0" actId="1366"/>
          <ac:picMkLst>
            <pc:docMk/>
            <pc:sldMk cId="772863212" sldId="257"/>
            <ac:picMk id="56" creationId="{00000000-0000-0000-0000-000000000000}"/>
          </ac:picMkLst>
        </pc:picChg>
        <pc:picChg chg="mod">
          <ac:chgData name="Dominik Aumann" userId="013c187a20e8f01a" providerId="LiveId" clId="{88BF52E9-F0B9-4DC1-B20F-B1AA370E85CC}" dt="2024-02-26T00:52:16.142" v="0" actId="1366"/>
          <ac:picMkLst>
            <pc:docMk/>
            <pc:sldMk cId="772863212" sldId="257"/>
            <ac:picMk id="75" creationId="{00000000-0000-0000-0000-00000000000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29139" y="3914657"/>
            <a:ext cx="8263573" cy="2701171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58278" y="7140892"/>
            <a:ext cx="6805295" cy="322040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377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755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133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511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1889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267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645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0235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C3288-B103-4210-B5DD-BB93A28D6CFF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5D96-DD15-495F-949A-28CCDEBC3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1819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C3288-B103-4210-B5DD-BB93A28D6CFF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5D96-DD15-495F-949A-28CCDEBC3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4975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7493926" y="927616"/>
            <a:ext cx="2325818" cy="19757054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516474" y="927616"/>
            <a:ext cx="6815422" cy="19757054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C3288-B103-4210-B5DD-BB93A28D6CFF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5D96-DD15-495F-949A-28CCDEBC3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465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C3288-B103-4210-B5DD-BB93A28D6CFF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5D96-DD15-495F-949A-28CCDEBC3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249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67959" y="8097680"/>
            <a:ext cx="8263573" cy="2502813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67959" y="5341086"/>
            <a:ext cx="8263573" cy="2756594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37794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75588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1338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5117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18897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26764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64558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0235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C3288-B103-4210-B5DD-BB93A28D6CFF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5D96-DD15-495F-949A-28CCDEBC3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855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516473" y="5402343"/>
            <a:ext cx="4570620" cy="15282328"/>
          </a:xfrm>
        </p:spPr>
        <p:txBody>
          <a:bodyPr/>
          <a:lstStyle>
            <a:lvl1pPr>
              <a:defRPr sz="3900"/>
            </a:lvl1pPr>
            <a:lvl2pPr>
              <a:defRPr sz="33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5249124" y="5402343"/>
            <a:ext cx="4570620" cy="15282328"/>
          </a:xfrm>
        </p:spPr>
        <p:txBody>
          <a:bodyPr/>
          <a:lstStyle>
            <a:lvl1pPr>
              <a:defRPr sz="3900"/>
            </a:lvl1pPr>
            <a:lvl2pPr>
              <a:defRPr sz="33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C3288-B103-4210-B5DD-BB93A28D6CFF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5D96-DD15-495F-949A-28CCDEBC3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57883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86093" y="504647"/>
            <a:ext cx="8749665" cy="2100263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86093" y="2820770"/>
            <a:ext cx="4295505" cy="1175563"/>
          </a:xfrm>
        </p:spPr>
        <p:txBody>
          <a:bodyPr anchor="b"/>
          <a:lstStyle>
            <a:lvl1pPr marL="0" indent="0">
              <a:buNone/>
              <a:defRPr sz="3300" b="1"/>
            </a:lvl1pPr>
            <a:lvl2pPr marL="637794" indent="0">
              <a:buNone/>
              <a:defRPr sz="2800" b="1"/>
            </a:lvl2pPr>
            <a:lvl3pPr marL="1275588" indent="0">
              <a:buNone/>
              <a:defRPr sz="2500" b="1"/>
            </a:lvl3pPr>
            <a:lvl4pPr marL="1913382" indent="0">
              <a:buNone/>
              <a:defRPr sz="2200" b="1"/>
            </a:lvl4pPr>
            <a:lvl5pPr marL="2551176" indent="0">
              <a:buNone/>
              <a:defRPr sz="2200" b="1"/>
            </a:lvl5pPr>
            <a:lvl6pPr marL="3188970" indent="0">
              <a:buNone/>
              <a:defRPr sz="2200" b="1"/>
            </a:lvl6pPr>
            <a:lvl7pPr marL="3826764" indent="0">
              <a:buNone/>
              <a:defRPr sz="2200" b="1"/>
            </a:lvl7pPr>
            <a:lvl8pPr marL="4464558" indent="0">
              <a:buNone/>
              <a:defRPr sz="2200" b="1"/>
            </a:lvl8pPr>
            <a:lvl9pPr marL="5102352" indent="0">
              <a:buNone/>
              <a:defRPr sz="2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86093" y="3996333"/>
            <a:ext cx="4295505" cy="726049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938565" y="2820770"/>
            <a:ext cx="4297193" cy="1175563"/>
          </a:xfrm>
        </p:spPr>
        <p:txBody>
          <a:bodyPr anchor="b"/>
          <a:lstStyle>
            <a:lvl1pPr marL="0" indent="0">
              <a:buNone/>
              <a:defRPr sz="3300" b="1"/>
            </a:lvl1pPr>
            <a:lvl2pPr marL="637794" indent="0">
              <a:buNone/>
              <a:defRPr sz="2800" b="1"/>
            </a:lvl2pPr>
            <a:lvl3pPr marL="1275588" indent="0">
              <a:buNone/>
              <a:defRPr sz="2500" b="1"/>
            </a:lvl3pPr>
            <a:lvl4pPr marL="1913382" indent="0">
              <a:buNone/>
              <a:defRPr sz="2200" b="1"/>
            </a:lvl4pPr>
            <a:lvl5pPr marL="2551176" indent="0">
              <a:buNone/>
              <a:defRPr sz="2200" b="1"/>
            </a:lvl5pPr>
            <a:lvl6pPr marL="3188970" indent="0">
              <a:buNone/>
              <a:defRPr sz="2200" b="1"/>
            </a:lvl6pPr>
            <a:lvl7pPr marL="3826764" indent="0">
              <a:buNone/>
              <a:defRPr sz="2200" b="1"/>
            </a:lvl7pPr>
            <a:lvl8pPr marL="4464558" indent="0">
              <a:buNone/>
              <a:defRPr sz="2200" b="1"/>
            </a:lvl8pPr>
            <a:lvl9pPr marL="5102352" indent="0">
              <a:buNone/>
              <a:defRPr sz="22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938565" y="3996333"/>
            <a:ext cx="4297193" cy="726049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C3288-B103-4210-B5DD-BB93A28D6CFF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5D96-DD15-495F-949A-28CCDEBC3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0028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C3288-B103-4210-B5DD-BB93A28D6CFF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5D96-DD15-495F-949A-28CCDEBC3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5746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C3288-B103-4210-B5DD-BB93A28D6CFF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5D96-DD15-495F-949A-28CCDEBC3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3809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86093" y="501729"/>
            <a:ext cx="3198422" cy="2135267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00973" y="501730"/>
            <a:ext cx="5434784" cy="10755095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3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86093" y="2636997"/>
            <a:ext cx="3198422" cy="8619828"/>
          </a:xfrm>
        </p:spPr>
        <p:txBody>
          <a:bodyPr/>
          <a:lstStyle>
            <a:lvl1pPr marL="0" indent="0">
              <a:buNone/>
              <a:defRPr sz="2000"/>
            </a:lvl1pPr>
            <a:lvl2pPr marL="637794" indent="0">
              <a:buNone/>
              <a:defRPr sz="1700"/>
            </a:lvl2pPr>
            <a:lvl3pPr marL="1275588" indent="0">
              <a:buNone/>
              <a:defRPr sz="1400"/>
            </a:lvl3pPr>
            <a:lvl4pPr marL="1913382" indent="0">
              <a:buNone/>
              <a:defRPr sz="1300"/>
            </a:lvl4pPr>
            <a:lvl5pPr marL="2551176" indent="0">
              <a:buNone/>
              <a:defRPr sz="1300"/>
            </a:lvl5pPr>
            <a:lvl6pPr marL="3188970" indent="0">
              <a:buNone/>
              <a:defRPr sz="1300"/>
            </a:lvl6pPr>
            <a:lvl7pPr marL="3826764" indent="0">
              <a:buNone/>
              <a:defRPr sz="1300"/>
            </a:lvl7pPr>
            <a:lvl8pPr marL="4464558" indent="0">
              <a:buNone/>
              <a:defRPr sz="1300"/>
            </a:lvl8pPr>
            <a:lvl9pPr marL="5102352" indent="0">
              <a:buNone/>
              <a:defRPr sz="13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C3288-B103-4210-B5DD-BB93A28D6CFF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5D96-DD15-495F-949A-28CCDEBC3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3354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05551" y="8821103"/>
            <a:ext cx="5833110" cy="1041381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905551" y="1125974"/>
            <a:ext cx="5833110" cy="7560945"/>
          </a:xfrm>
        </p:spPr>
        <p:txBody>
          <a:bodyPr/>
          <a:lstStyle>
            <a:lvl1pPr marL="0" indent="0">
              <a:buNone/>
              <a:defRPr sz="4500"/>
            </a:lvl1pPr>
            <a:lvl2pPr marL="637794" indent="0">
              <a:buNone/>
              <a:defRPr sz="3900"/>
            </a:lvl2pPr>
            <a:lvl3pPr marL="1275588" indent="0">
              <a:buNone/>
              <a:defRPr sz="3300"/>
            </a:lvl3pPr>
            <a:lvl4pPr marL="1913382" indent="0">
              <a:buNone/>
              <a:defRPr sz="2800"/>
            </a:lvl4pPr>
            <a:lvl5pPr marL="2551176" indent="0">
              <a:buNone/>
              <a:defRPr sz="2800"/>
            </a:lvl5pPr>
            <a:lvl6pPr marL="3188970" indent="0">
              <a:buNone/>
              <a:defRPr sz="2800"/>
            </a:lvl6pPr>
            <a:lvl7pPr marL="3826764" indent="0">
              <a:buNone/>
              <a:defRPr sz="2800"/>
            </a:lvl7pPr>
            <a:lvl8pPr marL="4464558" indent="0">
              <a:buNone/>
              <a:defRPr sz="2800"/>
            </a:lvl8pPr>
            <a:lvl9pPr marL="5102352" indent="0">
              <a:buNone/>
              <a:defRPr sz="28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905551" y="9862484"/>
            <a:ext cx="5833110" cy="1478934"/>
          </a:xfrm>
        </p:spPr>
        <p:txBody>
          <a:bodyPr/>
          <a:lstStyle>
            <a:lvl1pPr marL="0" indent="0">
              <a:buNone/>
              <a:defRPr sz="2000"/>
            </a:lvl1pPr>
            <a:lvl2pPr marL="637794" indent="0">
              <a:buNone/>
              <a:defRPr sz="1700"/>
            </a:lvl2pPr>
            <a:lvl3pPr marL="1275588" indent="0">
              <a:buNone/>
              <a:defRPr sz="1400"/>
            </a:lvl3pPr>
            <a:lvl4pPr marL="1913382" indent="0">
              <a:buNone/>
              <a:defRPr sz="1300"/>
            </a:lvl4pPr>
            <a:lvl5pPr marL="2551176" indent="0">
              <a:buNone/>
              <a:defRPr sz="1300"/>
            </a:lvl5pPr>
            <a:lvl6pPr marL="3188970" indent="0">
              <a:buNone/>
              <a:defRPr sz="1300"/>
            </a:lvl6pPr>
            <a:lvl7pPr marL="3826764" indent="0">
              <a:buNone/>
              <a:defRPr sz="1300"/>
            </a:lvl7pPr>
            <a:lvl8pPr marL="4464558" indent="0">
              <a:buNone/>
              <a:defRPr sz="1300"/>
            </a:lvl8pPr>
            <a:lvl9pPr marL="5102352" indent="0">
              <a:buNone/>
              <a:defRPr sz="13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0C3288-B103-4210-B5DD-BB93A28D6CFF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75D96-DD15-495F-949A-28CCDEBC3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6120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86093" y="504647"/>
            <a:ext cx="8749665" cy="2100263"/>
          </a:xfrm>
          <a:prstGeom prst="rect">
            <a:avLst/>
          </a:prstGeom>
        </p:spPr>
        <p:txBody>
          <a:bodyPr vert="horz" lIns="127559" tIns="63779" rIns="127559" bIns="63779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86093" y="2940368"/>
            <a:ext cx="8749665" cy="8316457"/>
          </a:xfrm>
          <a:prstGeom prst="rect">
            <a:avLst/>
          </a:prstGeom>
        </p:spPr>
        <p:txBody>
          <a:bodyPr vert="horz" lIns="127559" tIns="63779" rIns="127559" bIns="63779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86092" y="11679794"/>
            <a:ext cx="2268432" cy="670917"/>
          </a:xfrm>
          <a:prstGeom prst="rect">
            <a:avLst/>
          </a:prstGeom>
        </p:spPr>
        <p:txBody>
          <a:bodyPr vert="horz" lIns="127559" tIns="63779" rIns="127559" bIns="63779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0C3288-B103-4210-B5DD-BB93A28D6CFF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321632" y="11679794"/>
            <a:ext cx="3078586" cy="670917"/>
          </a:xfrm>
          <a:prstGeom prst="rect">
            <a:avLst/>
          </a:prstGeom>
        </p:spPr>
        <p:txBody>
          <a:bodyPr vert="horz" lIns="127559" tIns="63779" rIns="127559" bIns="63779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967326" y="11679794"/>
            <a:ext cx="2268432" cy="670917"/>
          </a:xfrm>
          <a:prstGeom prst="rect">
            <a:avLst/>
          </a:prstGeom>
        </p:spPr>
        <p:txBody>
          <a:bodyPr vert="horz" lIns="127559" tIns="63779" rIns="127559" bIns="63779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75D96-DD15-495F-949A-28CCDEBC342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467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75588" rtl="0" eaLnBrk="1" latinLnBrk="0" hangingPunct="1">
        <a:spcBef>
          <a:spcPct val="0"/>
        </a:spcBef>
        <a:buNone/>
        <a:defRPr sz="6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78346" indent="-478346" algn="l" defTabSz="1275588" rtl="0" eaLnBrk="1" latinLnBrk="0" hangingPunct="1">
        <a:spcBef>
          <a:spcPct val="20000"/>
        </a:spcBef>
        <a:buFont typeface="Arial" panose="020B0604020202020204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36415" indent="-398621" algn="l" defTabSz="1275588" rtl="0" eaLnBrk="1" latinLnBrk="0" hangingPunct="1">
        <a:spcBef>
          <a:spcPct val="20000"/>
        </a:spcBef>
        <a:buFont typeface="Arial" panose="020B0604020202020204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594485" indent="-318897" algn="l" defTabSz="1275588" rtl="0" eaLnBrk="1" latinLnBrk="0" hangingPunct="1">
        <a:spcBef>
          <a:spcPct val="20000"/>
        </a:spcBef>
        <a:buFont typeface="Arial" panose="020B0604020202020204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3pPr>
      <a:lvl4pPr marL="2232279" indent="-318897" algn="l" defTabSz="1275588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70073" indent="-318897" algn="l" defTabSz="1275588" rtl="0" eaLnBrk="1" latinLnBrk="0" hangingPunct="1">
        <a:spcBef>
          <a:spcPct val="20000"/>
        </a:spcBef>
        <a:buFont typeface="Arial" panose="020B0604020202020204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07867" indent="-318897" algn="l" defTabSz="1275588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45661" indent="-318897" algn="l" defTabSz="1275588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783455" indent="-318897" algn="l" defTabSz="1275588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21249" indent="-318897" algn="l" defTabSz="1275588" rtl="0" eaLnBrk="1" latinLnBrk="0" hangingPunct="1">
        <a:spcBef>
          <a:spcPct val="20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275588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37794" algn="l" defTabSz="1275588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75588" algn="l" defTabSz="1275588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13382" algn="l" defTabSz="1275588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51176" algn="l" defTabSz="1275588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88970" algn="l" defTabSz="1275588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26764" algn="l" defTabSz="1275588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64558" algn="l" defTabSz="1275588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02352" algn="l" defTabSz="1275588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Picture 2" descr="D:\plots\Supp4.2_041_0134.png"/>
          <p:cNvPicPr>
            <a:picLocks noChangeAspect="1" noChangeArrowheads="1"/>
          </p:cNvPicPr>
          <p:nvPr/>
        </p:nvPicPr>
        <p:blipFill>
          <a:blip r:embed="rId2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12213" y="1013784"/>
            <a:ext cx="4353351" cy="15912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76" name="Gerade Verbindung 75"/>
          <p:cNvCxnSpPr/>
          <p:nvPr/>
        </p:nvCxnSpPr>
        <p:spPr>
          <a:xfrm flipH="1">
            <a:off x="5164099" y="1867977"/>
            <a:ext cx="4261069" cy="2208"/>
          </a:xfrm>
          <a:prstGeom prst="line">
            <a:avLst/>
          </a:prstGeom>
          <a:ln w="12700">
            <a:solidFill>
              <a:srgbClr val="339E66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6" name="Picture 3" descr="D:\plots\Supp4.1_032_0116.png"/>
          <p:cNvPicPr>
            <a:picLocks noChangeAspect="1" noChangeArrowheads="1"/>
          </p:cNvPicPr>
          <p:nvPr/>
        </p:nvPicPr>
        <p:blipFill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5940" y="1013251"/>
            <a:ext cx="4354810" cy="15917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" name="Grafik 6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3648" y="3305898"/>
            <a:ext cx="4339585" cy="1627200"/>
          </a:xfrm>
          <a:prstGeom prst="rect">
            <a:avLst/>
          </a:prstGeom>
        </p:spPr>
      </p:pic>
      <p:pic>
        <p:nvPicPr>
          <p:cNvPr id="64" name="Grafik 6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456"/>
          <a:stretch/>
        </p:blipFill>
        <p:spPr>
          <a:xfrm>
            <a:off x="4856746" y="5590477"/>
            <a:ext cx="4590322" cy="1369130"/>
          </a:xfrm>
          <a:prstGeom prst="rect">
            <a:avLst/>
          </a:prstGeom>
        </p:spPr>
      </p:pic>
      <p:pic>
        <p:nvPicPr>
          <p:cNvPr id="50" name="Grafik 49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532"/>
          <a:stretch/>
        </p:blipFill>
        <p:spPr>
          <a:xfrm>
            <a:off x="229358" y="5597966"/>
            <a:ext cx="4530201" cy="1366887"/>
          </a:xfrm>
          <a:prstGeom prst="rect">
            <a:avLst/>
          </a:prstGeom>
        </p:spPr>
      </p:pic>
      <p:pic>
        <p:nvPicPr>
          <p:cNvPr id="43" name="Picture 2" descr="\\149.148.31.83\vivienne\nanopore_aneuploidy\Publication\Paper\Figures\prepared\suppl_fig4_ID0116_profile.tif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6937" y="3305898"/>
            <a:ext cx="4337964" cy="16267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Google Shape;91;p1"/>
          <p:cNvSpPr txBox="1"/>
          <p:nvPr/>
        </p:nvSpPr>
        <p:spPr>
          <a:xfrm>
            <a:off x="426770" y="694579"/>
            <a:ext cx="4274097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u="sng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CGH</a:t>
            </a:r>
            <a:r>
              <a:rPr lang="en-US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2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neuploid</a:t>
            </a:r>
            <a:r>
              <a:rPr lang="en-US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 (-21)</a:t>
            </a:r>
            <a:endParaRPr sz="12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10" name="Google Shape;91;p1"/>
          <p:cNvSpPr txBox="1"/>
          <p:nvPr/>
        </p:nvSpPr>
        <p:spPr>
          <a:xfrm>
            <a:off x="972493" y="7013639"/>
            <a:ext cx="2976381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 300k</a:t>
            </a:r>
            <a:r>
              <a:rPr lang="en-US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2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euploid</a:t>
            </a:r>
            <a:endParaRPr sz="12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12" name="Google Shape;91;p1"/>
          <p:cNvSpPr txBox="1"/>
          <p:nvPr/>
        </p:nvSpPr>
        <p:spPr>
          <a:xfrm>
            <a:off x="1052900" y="5364683"/>
            <a:ext cx="2976381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de-DE" sz="12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</a:t>
            </a:r>
            <a:r>
              <a:rPr lang="de-DE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de-DE" sz="12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Chromosome</a:t>
            </a:r>
            <a:r>
              <a:rPr lang="de-DE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 21</a:t>
            </a:r>
            <a:endParaRPr sz="12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5028918" y="199620"/>
            <a:ext cx="22322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Consolas" panose="020B0609020204030204" pitchFamily="49" charset="0"/>
              </a:rPr>
              <a:t>SAMPLE ID041</a:t>
            </a:r>
          </a:p>
        </p:txBody>
      </p:sp>
      <p:sp>
        <p:nvSpPr>
          <p:cNvPr id="17" name="Google Shape;91;p1"/>
          <p:cNvSpPr txBox="1"/>
          <p:nvPr/>
        </p:nvSpPr>
        <p:spPr>
          <a:xfrm>
            <a:off x="5172784" y="702179"/>
            <a:ext cx="4252384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u="sng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CGH</a:t>
            </a:r>
            <a:r>
              <a:rPr lang="en-US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2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euploid</a:t>
            </a:r>
            <a:endParaRPr sz="12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22" name="Google Shape;91;p1"/>
          <p:cNvSpPr txBox="1"/>
          <p:nvPr/>
        </p:nvSpPr>
        <p:spPr>
          <a:xfrm>
            <a:off x="5916992" y="7047910"/>
            <a:ext cx="2976381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 300k</a:t>
            </a:r>
            <a:r>
              <a:rPr lang="en-US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2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neuploid</a:t>
            </a:r>
            <a:r>
              <a:rPr lang="en-US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 (+1, +22)</a:t>
            </a:r>
            <a:endParaRPr sz="12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94193" y="612155"/>
            <a:ext cx="45491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64238" y="2869361"/>
            <a:ext cx="4045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94193" y="5300165"/>
            <a:ext cx="4045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c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64236" y="6943356"/>
            <a:ext cx="4045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d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64236" y="9035019"/>
            <a:ext cx="4045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e</a:t>
            </a:r>
          </a:p>
        </p:txBody>
      </p:sp>
      <p:sp>
        <p:nvSpPr>
          <p:cNvPr id="30" name="Google Shape;91;p1"/>
          <p:cNvSpPr txBox="1"/>
          <p:nvPr/>
        </p:nvSpPr>
        <p:spPr>
          <a:xfrm>
            <a:off x="5772976" y="5364683"/>
            <a:ext cx="2976381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 algn="ctr"/>
            <a:r>
              <a:rPr lang="de-DE" sz="12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</a:t>
            </a:r>
            <a:r>
              <a:rPr lang="de-DE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de-DE" sz="12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Chromosome</a:t>
            </a:r>
            <a:r>
              <a:rPr lang="de-DE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 1</a:t>
            </a:r>
            <a:endParaRPr sz="12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31" name="Google Shape;91;p1"/>
          <p:cNvSpPr txBox="1"/>
          <p:nvPr/>
        </p:nvSpPr>
        <p:spPr>
          <a:xfrm>
            <a:off x="5166792" y="3038638"/>
            <a:ext cx="4182947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</a:t>
            </a:r>
            <a:r>
              <a:rPr lang="en-US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2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euploid</a:t>
            </a:r>
            <a:endParaRPr sz="12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32" name="Google Shape;91;p1"/>
          <p:cNvSpPr txBox="1"/>
          <p:nvPr/>
        </p:nvSpPr>
        <p:spPr>
          <a:xfrm>
            <a:off x="447871" y="3319684"/>
            <a:ext cx="2976381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/>
            <a:r>
              <a:rPr lang="de-DE" sz="9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1027508 </a:t>
            </a:r>
            <a:r>
              <a:rPr lang="de-DE" sz="9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reads</a:t>
            </a:r>
            <a:endParaRPr sz="9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33" name="Google Shape;91;p1"/>
          <p:cNvSpPr txBox="1"/>
          <p:nvPr/>
        </p:nvSpPr>
        <p:spPr>
          <a:xfrm>
            <a:off x="5189711" y="3351953"/>
            <a:ext cx="2976381" cy="2463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/>
            <a:r>
              <a:rPr lang="de-DE" sz="9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756703 </a:t>
            </a:r>
            <a:r>
              <a:rPr lang="de-DE" sz="9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reads</a:t>
            </a:r>
            <a:endParaRPr lang="de-DE" sz="9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35" name="Google Shape;91;p1"/>
          <p:cNvSpPr txBox="1"/>
          <p:nvPr/>
        </p:nvSpPr>
        <p:spPr>
          <a:xfrm>
            <a:off x="5164099" y="7373362"/>
            <a:ext cx="2976381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/>
            <a:r>
              <a:rPr lang="de-DE" sz="9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300000 </a:t>
            </a:r>
            <a:r>
              <a:rPr lang="de-DE" sz="9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reads</a:t>
            </a:r>
            <a:endParaRPr sz="9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36" name="Google Shape;91;p1"/>
          <p:cNvSpPr txBox="1"/>
          <p:nvPr/>
        </p:nvSpPr>
        <p:spPr>
          <a:xfrm>
            <a:off x="1049286" y="9306627"/>
            <a:ext cx="2976381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algn="ctr"/>
            <a:r>
              <a:rPr lang="de-DE" sz="12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 300k</a:t>
            </a:r>
            <a:r>
              <a:rPr lang="de-DE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de-DE" sz="12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Chromosome</a:t>
            </a:r>
            <a:r>
              <a:rPr lang="de-DE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 21</a:t>
            </a:r>
          </a:p>
        </p:txBody>
      </p:sp>
      <p:sp>
        <p:nvSpPr>
          <p:cNvPr id="38" name="Google Shape;87;p1"/>
          <p:cNvSpPr txBox="1"/>
          <p:nvPr/>
        </p:nvSpPr>
        <p:spPr>
          <a:xfrm>
            <a:off x="335456" y="199620"/>
            <a:ext cx="1970463" cy="4125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/>
            <a:r>
              <a:rPr lang="en-US" sz="1600" b="1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SAMPLE ID032</a:t>
            </a:r>
            <a:endParaRPr sz="1600" b="1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40" name="Textfeld 39"/>
          <p:cNvSpPr txBox="1"/>
          <p:nvPr/>
        </p:nvSpPr>
        <p:spPr>
          <a:xfrm rot="16200000">
            <a:off x="-330987" y="1686362"/>
            <a:ext cx="12239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41" name="Textfeld 40"/>
          <p:cNvSpPr txBox="1"/>
          <p:nvPr/>
        </p:nvSpPr>
        <p:spPr>
          <a:xfrm>
            <a:off x="426770" y="2575386"/>
            <a:ext cx="42740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cxnSp>
        <p:nvCxnSpPr>
          <p:cNvPr id="42" name="Gerade Verbindung 41"/>
          <p:cNvCxnSpPr/>
          <p:nvPr/>
        </p:nvCxnSpPr>
        <p:spPr>
          <a:xfrm flipH="1">
            <a:off x="433285" y="1870372"/>
            <a:ext cx="4261069" cy="2208"/>
          </a:xfrm>
          <a:prstGeom prst="line">
            <a:avLst/>
          </a:prstGeom>
          <a:ln w="12700">
            <a:solidFill>
              <a:srgbClr val="339E66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feld 43"/>
          <p:cNvSpPr txBox="1"/>
          <p:nvPr/>
        </p:nvSpPr>
        <p:spPr>
          <a:xfrm>
            <a:off x="420256" y="4860966"/>
            <a:ext cx="42966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46" name="Google Shape;87;p1"/>
          <p:cNvSpPr txBox="1"/>
          <p:nvPr/>
        </p:nvSpPr>
        <p:spPr>
          <a:xfrm>
            <a:off x="420256" y="3023878"/>
            <a:ext cx="4197463" cy="3245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</a:t>
            </a:r>
            <a:r>
              <a:rPr lang="en-US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en-US" sz="12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aneuploid</a:t>
            </a:r>
            <a:r>
              <a:rPr lang="en-US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 (-21)</a:t>
            </a:r>
            <a:endParaRPr sz="12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cxnSp>
        <p:nvCxnSpPr>
          <p:cNvPr id="47" name="Gerade Verbindung mit Pfeil 46"/>
          <p:cNvCxnSpPr/>
          <p:nvPr/>
        </p:nvCxnSpPr>
        <p:spPr>
          <a:xfrm flipH="1" flipV="1">
            <a:off x="4315729" y="2197430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 Verbindung mit Pfeil 47"/>
          <p:cNvCxnSpPr/>
          <p:nvPr/>
        </p:nvCxnSpPr>
        <p:spPr>
          <a:xfrm flipH="1" flipV="1">
            <a:off x="4315729" y="4356571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/>
          <p:nvPr/>
        </p:nvCxnSpPr>
        <p:spPr>
          <a:xfrm flipH="1" flipV="1">
            <a:off x="4274590" y="8111735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" name="Grafik 5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638" y="7281851"/>
            <a:ext cx="4325643" cy="1621972"/>
          </a:xfrm>
          <a:prstGeom prst="rect">
            <a:avLst/>
          </a:prstGeom>
        </p:spPr>
      </p:pic>
      <p:sp>
        <p:nvSpPr>
          <p:cNvPr id="34" name="Google Shape;91;p1"/>
          <p:cNvSpPr txBox="1"/>
          <p:nvPr/>
        </p:nvSpPr>
        <p:spPr>
          <a:xfrm>
            <a:off x="516186" y="7364042"/>
            <a:ext cx="2976381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lvl="0"/>
            <a:r>
              <a:rPr lang="de-DE" sz="9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300000 </a:t>
            </a:r>
            <a:r>
              <a:rPr lang="de-DE" sz="9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reads</a:t>
            </a:r>
            <a:endParaRPr sz="900" dirty="0">
              <a:solidFill>
                <a:schemeClr val="dk1"/>
              </a:solidFill>
              <a:latin typeface="Consolas"/>
              <a:ea typeface="Consolas"/>
              <a:cs typeface="Consolas"/>
              <a:sym typeface="Consolas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468785" y="8817007"/>
            <a:ext cx="42966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53" name="Textfeld 52"/>
          <p:cNvSpPr txBox="1"/>
          <p:nvPr/>
        </p:nvSpPr>
        <p:spPr>
          <a:xfrm rot="16200000">
            <a:off x="-520929" y="7957741"/>
            <a:ext cx="1633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54" name="Textfeld 53"/>
          <p:cNvSpPr txBox="1"/>
          <p:nvPr/>
        </p:nvSpPr>
        <p:spPr>
          <a:xfrm rot="16200000">
            <a:off x="4406160" y="1686361"/>
            <a:ext cx="122399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45" name="Textfeld 44"/>
          <p:cNvSpPr txBox="1"/>
          <p:nvPr/>
        </p:nvSpPr>
        <p:spPr>
          <a:xfrm rot="16200000">
            <a:off x="-535737" y="4001700"/>
            <a:ext cx="1633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pic>
        <p:nvPicPr>
          <p:cNvPr id="58" name="Grafik 57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023"/>
          <a:stretch/>
        </p:blipFill>
        <p:spPr>
          <a:xfrm>
            <a:off x="237120" y="9540627"/>
            <a:ext cx="4583182" cy="1357256"/>
          </a:xfrm>
          <a:prstGeom prst="rect">
            <a:avLst/>
          </a:prstGeom>
        </p:spPr>
      </p:pic>
      <p:sp>
        <p:nvSpPr>
          <p:cNvPr id="61" name="Textfeld 60"/>
          <p:cNvSpPr txBox="1"/>
          <p:nvPr/>
        </p:nvSpPr>
        <p:spPr>
          <a:xfrm rot="16200000">
            <a:off x="4158739" y="3981890"/>
            <a:ext cx="1633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cxnSp>
        <p:nvCxnSpPr>
          <p:cNvPr id="62" name="Gerade Verbindung mit Pfeil 61"/>
          <p:cNvCxnSpPr/>
          <p:nvPr/>
        </p:nvCxnSpPr>
        <p:spPr>
          <a:xfrm flipH="1" flipV="1">
            <a:off x="5376466" y="2042585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Gerade Verbindung mit Pfeil 62"/>
          <p:cNvCxnSpPr/>
          <p:nvPr/>
        </p:nvCxnSpPr>
        <p:spPr>
          <a:xfrm flipH="1" flipV="1">
            <a:off x="5412937" y="4257399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5" name="Grafik 6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1881" y="7298577"/>
            <a:ext cx="4357307" cy="1633846"/>
          </a:xfrm>
          <a:prstGeom prst="rect">
            <a:avLst/>
          </a:prstGeom>
        </p:spPr>
      </p:pic>
      <p:sp>
        <p:nvSpPr>
          <p:cNvPr id="60" name="Textfeld 59"/>
          <p:cNvSpPr txBox="1"/>
          <p:nvPr/>
        </p:nvSpPr>
        <p:spPr>
          <a:xfrm>
            <a:off x="5172784" y="4841156"/>
            <a:ext cx="42966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5292973" y="8834571"/>
            <a:ext cx="429665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 rot="16200000">
            <a:off x="4303607" y="8017821"/>
            <a:ext cx="16335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cxnSp>
        <p:nvCxnSpPr>
          <p:cNvPr id="69" name="Gerade Verbindung mit Pfeil 68"/>
          <p:cNvCxnSpPr/>
          <p:nvPr/>
        </p:nvCxnSpPr>
        <p:spPr>
          <a:xfrm flipH="1" flipV="1">
            <a:off x="5565336" y="8269887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0" name="Grafik 6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505"/>
          <a:stretch/>
        </p:blipFill>
        <p:spPr>
          <a:xfrm>
            <a:off x="4796128" y="9451079"/>
            <a:ext cx="4892002" cy="1458220"/>
          </a:xfrm>
          <a:prstGeom prst="rect">
            <a:avLst/>
          </a:prstGeom>
        </p:spPr>
      </p:pic>
      <p:sp>
        <p:nvSpPr>
          <p:cNvPr id="37" name="Google Shape;91;p1"/>
          <p:cNvSpPr txBox="1"/>
          <p:nvPr/>
        </p:nvSpPr>
        <p:spPr>
          <a:xfrm>
            <a:off x="5941045" y="9306627"/>
            <a:ext cx="2976381" cy="23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0000" tIns="45000" rIns="90000" bIns="45000" anchor="t" anchorCtr="0">
            <a:noAutofit/>
          </a:bodyPr>
          <a:lstStyle/>
          <a:p>
            <a:pPr algn="ctr"/>
            <a:r>
              <a:rPr lang="de-DE" sz="1200" u="sng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ONT 300k</a:t>
            </a:r>
            <a:r>
              <a:rPr lang="de-DE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: </a:t>
            </a:r>
            <a:r>
              <a:rPr lang="de-DE" sz="1200" dirty="0" err="1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Chromosome</a:t>
            </a:r>
            <a:r>
              <a:rPr lang="de-DE" sz="1200" dirty="0">
                <a:solidFill>
                  <a:schemeClr val="dk1"/>
                </a:solidFill>
                <a:latin typeface="Consolas"/>
                <a:ea typeface="Consolas"/>
                <a:cs typeface="Consolas"/>
                <a:sym typeface="Consolas"/>
              </a:rPr>
              <a:t> 1</a:t>
            </a:r>
          </a:p>
        </p:txBody>
      </p:sp>
      <p:cxnSp>
        <p:nvCxnSpPr>
          <p:cNvPr id="71" name="Gerade Verbindung mit Pfeil 70"/>
          <p:cNvCxnSpPr/>
          <p:nvPr/>
        </p:nvCxnSpPr>
        <p:spPr>
          <a:xfrm flipH="1" flipV="1">
            <a:off x="4340517" y="8565955"/>
            <a:ext cx="82277" cy="158152"/>
          </a:xfrm>
          <a:prstGeom prst="straightConnector1">
            <a:avLst/>
          </a:prstGeom>
          <a:ln w="19050">
            <a:solidFill>
              <a:schemeClr val="tx1">
                <a:lumMod val="50000"/>
                <a:lumOff val="50000"/>
              </a:schemeClr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feld 1"/>
          <p:cNvSpPr txBox="1"/>
          <p:nvPr/>
        </p:nvSpPr>
        <p:spPr>
          <a:xfrm>
            <a:off x="8022476" y="42654"/>
            <a:ext cx="148979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dirty="0"/>
              <a:t>Suppl. Fig 4</a:t>
            </a:r>
          </a:p>
        </p:txBody>
      </p:sp>
      <p:pic>
        <p:nvPicPr>
          <p:cNvPr id="72" name="Picture 2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7219" y="11265496"/>
            <a:ext cx="4147413" cy="7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7" name="Textfeld 76"/>
          <p:cNvSpPr txBox="1"/>
          <p:nvPr/>
        </p:nvSpPr>
        <p:spPr>
          <a:xfrm>
            <a:off x="5166792" y="2575386"/>
            <a:ext cx="42740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2863212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</Words>
  <Application>Microsoft Office PowerPoint</Application>
  <PresentationFormat>Benutzerdefiniert</PresentationFormat>
  <Paragraphs>34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ilvia</dc:creator>
  <cp:lastModifiedBy>Vivienne</cp:lastModifiedBy>
  <cp:revision>16</cp:revision>
  <dcterms:created xsi:type="dcterms:W3CDTF">2023-10-31T08:39:19Z</dcterms:created>
  <dcterms:modified xsi:type="dcterms:W3CDTF">2024-02-26T13:09:26Z</dcterms:modified>
</cp:coreProperties>
</file>